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12192000" cy="8999538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56" d="100"/>
          <a:sy n="56" d="100"/>
        </p:scale>
        <p:origin x="126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Dr%20Emri%20Tam&#225;s\Documents\2025\0%20Kinga\0%20MeaB%20BMC%20Genomics\help\Aku%20-%20Af293\Munkaf&#252;zet1.xlsx" TargetMode="Externa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chartUserShapes" Target="../drawings/drawing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hu-HU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6.3083333333333338E-2"/>
          <c:y val="3.3070270418702294E-2"/>
          <c:w val="0.88969444444444445"/>
          <c:h val="0.85835656527335003"/>
        </c:manualLayout>
      </c:layout>
      <c:barChart>
        <c:barDir val="bar"/>
        <c:grouping val="clustered"/>
        <c:varyColors val="0"/>
        <c:ser>
          <c:idx val="0"/>
          <c:order val="0"/>
          <c:tx>
            <c:strRef>
              <c:f>Munka1!$B$5</c:f>
              <c:strCache>
                <c:ptCount val="1"/>
                <c:pt idx="0">
                  <c:v>Af293</c:v>
                </c:pt>
              </c:strCache>
            </c:strRef>
          </c:tx>
          <c:spPr>
            <a:solidFill>
              <a:schemeClr val="accent1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Munka1!$F$5:$H$5</c:f>
                <c:numCache>
                  <c:formatCode>General</c:formatCode>
                  <c:ptCount val="3"/>
                  <c:pt idx="0">
                    <c:v>0.9836336718970865</c:v>
                  </c:pt>
                  <c:pt idx="1">
                    <c:v>0.98363367189708972</c:v>
                  </c:pt>
                  <c:pt idx="2">
                    <c:v>0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Munka1!$C$4:$E$4</c:f>
              <c:strCache>
                <c:ptCount val="3"/>
                <c:pt idx="0">
                  <c:v>c</c:v>
                </c:pt>
                <c:pt idx="1">
                  <c:v>b</c:v>
                </c:pt>
                <c:pt idx="2">
                  <c:v>a</c:v>
                </c:pt>
              </c:strCache>
            </c:strRef>
          </c:cat>
          <c:val>
            <c:numRef>
              <c:f>Munka1!$C$5:$E$5</c:f>
              <c:numCache>
                <c:formatCode>General</c:formatCode>
                <c:ptCount val="3"/>
                <c:pt idx="0">
                  <c:v>45.290404040404042</c:v>
                </c:pt>
                <c:pt idx="1">
                  <c:v>57.095959595959606</c:v>
                </c:pt>
                <c:pt idx="2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BA0C-4C15-92DF-EB1EE39B4CFC}"/>
            </c:ext>
          </c:extLst>
        </c:ser>
        <c:ser>
          <c:idx val="1"/>
          <c:order val="1"/>
          <c:tx>
            <c:strRef>
              <c:f>Munka1!$B$6</c:f>
              <c:strCache>
                <c:ptCount val="1"/>
                <c:pt idx="0">
                  <c:v>AkuB</c:v>
                </c:pt>
              </c:strCache>
            </c:strRef>
          </c:tx>
          <c:spPr>
            <a:solidFill>
              <a:schemeClr val="accent6">
                <a:lumMod val="7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Munka1!$F$6:$H$6</c:f>
                <c:numCache>
                  <c:formatCode>General</c:formatCode>
                  <c:ptCount val="3"/>
                  <c:pt idx="0">
                    <c:v>0.9836336718970865</c:v>
                  </c:pt>
                  <c:pt idx="1">
                    <c:v>0.37177858243271888</c:v>
                  </c:pt>
                  <c:pt idx="2">
                    <c:v>0.3717785824327138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Munka1!$C$4:$E$4</c:f>
              <c:strCache>
                <c:ptCount val="3"/>
                <c:pt idx="0">
                  <c:v>c</c:v>
                </c:pt>
                <c:pt idx="1">
                  <c:v>b</c:v>
                </c:pt>
                <c:pt idx="2">
                  <c:v>a</c:v>
                </c:pt>
              </c:strCache>
            </c:strRef>
          </c:cat>
          <c:val>
            <c:numRef>
              <c:f>Munka1!$C$6:$E$6</c:f>
              <c:numCache>
                <c:formatCode>General</c:formatCode>
                <c:ptCount val="3"/>
                <c:pt idx="0">
                  <c:v>38.851010101010104</c:v>
                </c:pt>
                <c:pt idx="1">
                  <c:v>59.457070707070699</c:v>
                </c:pt>
                <c:pt idx="2">
                  <c:v>18.88888888888888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BA0C-4C15-92DF-EB1EE39B4CF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-2103018672"/>
        <c:axId val="-2103013776"/>
      </c:barChart>
      <c:catAx>
        <c:axId val="-210301867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2103013776"/>
        <c:crosses val="autoZero"/>
        <c:auto val="1"/>
        <c:lblAlgn val="ctr"/>
        <c:lblOffset val="100"/>
        <c:noMultiLvlLbl val="0"/>
      </c:catAx>
      <c:valAx>
        <c:axId val="-210301377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8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hu-HU" sz="1800" b="1"/>
                  <a:t>Diameter (mm)</a:t>
                </a:r>
                <a:endParaRPr lang="en-US" sz="1800" b="1"/>
              </a:p>
            </c:rich>
          </c:tx>
          <c:layout>
            <c:manualLayout>
              <c:xMode val="edge"/>
              <c:yMode val="edge"/>
              <c:x val="0.3664722222222222"/>
              <c:y val="0.9474059071531005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8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2103018672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2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71214</cdr:x>
      <cdr:y>0.10869</cdr:y>
    </cdr:from>
    <cdr:to>
      <cdr:x>0.74364</cdr:x>
      <cdr:y>0.13103</cdr:y>
    </cdr:to>
    <cdr:sp macro="" textlink="">
      <cdr:nvSpPr>
        <cdr:cNvPr id="2" name="Téglalap 1"/>
        <cdr:cNvSpPr/>
      </cdr:nvSpPr>
      <cdr:spPr>
        <a:xfrm xmlns:a="http://schemas.openxmlformats.org/drawingml/2006/main">
          <a:off x="3255906" y="700771"/>
          <a:ext cx="144000" cy="144000"/>
        </a:xfrm>
        <a:prstGeom xmlns:a="http://schemas.openxmlformats.org/drawingml/2006/main" prst="rect">
          <a:avLst/>
        </a:prstGeom>
        <a:solidFill xmlns:a="http://schemas.openxmlformats.org/drawingml/2006/main">
          <a:schemeClr val="accent6">
            <a:lumMod val="75000"/>
          </a:schemeClr>
        </a:solidFill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endParaRPr lang="en-US"/>
        </a:p>
      </cdr:txBody>
    </cdr:sp>
  </cdr:relSizeAnchor>
  <cdr:relSizeAnchor xmlns:cdr="http://schemas.openxmlformats.org/drawingml/2006/chartDrawing">
    <cdr:from>
      <cdr:x>0.71214</cdr:x>
      <cdr:y>0.07246</cdr:y>
    </cdr:from>
    <cdr:to>
      <cdr:x>0.74364</cdr:x>
      <cdr:y>0.0948</cdr:y>
    </cdr:to>
    <cdr:sp macro="" textlink="">
      <cdr:nvSpPr>
        <cdr:cNvPr id="3" name="Téglalap 2"/>
        <cdr:cNvSpPr/>
      </cdr:nvSpPr>
      <cdr:spPr>
        <a:xfrm xmlns:a="http://schemas.openxmlformats.org/drawingml/2006/main">
          <a:off x="3255906" y="467200"/>
          <a:ext cx="144000" cy="144000"/>
        </a:xfrm>
        <a:prstGeom xmlns:a="http://schemas.openxmlformats.org/drawingml/2006/main" prst="rect">
          <a:avLst/>
        </a:prstGeom>
        <a:solidFill xmlns:a="http://schemas.openxmlformats.org/drawingml/2006/main">
          <a:schemeClr val="accent1">
            <a:lumMod val="75000"/>
          </a:schemeClr>
        </a:solidFill>
        <a:ln xmlns:a="http://schemas.openxmlformats.org/drawingml/2006/main">
          <a:solidFill>
            <a:schemeClr val="tx1"/>
          </a:solidFill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endParaRPr lang="en-US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472842"/>
            <a:ext cx="10363200" cy="3133172"/>
          </a:xfrm>
        </p:spPr>
        <p:txBody>
          <a:bodyPr anchor="b"/>
          <a:lstStyle>
            <a:lvl1pPr algn="ctr">
              <a:defRPr sz="7874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726842"/>
            <a:ext cx="9144000" cy="2172804"/>
          </a:xfrm>
        </p:spPr>
        <p:txBody>
          <a:bodyPr/>
          <a:lstStyle>
            <a:lvl1pPr marL="0" indent="0" algn="ctr">
              <a:buNone/>
              <a:defRPr sz="3150"/>
            </a:lvl1pPr>
            <a:lvl2pPr marL="599984" indent="0" algn="ctr">
              <a:buNone/>
              <a:defRPr sz="2625"/>
            </a:lvl2pPr>
            <a:lvl3pPr marL="1199967" indent="0" algn="ctr">
              <a:buNone/>
              <a:defRPr sz="2362"/>
            </a:lvl3pPr>
            <a:lvl4pPr marL="1799951" indent="0" algn="ctr">
              <a:buNone/>
              <a:defRPr sz="2100"/>
            </a:lvl4pPr>
            <a:lvl5pPr marL="2399934" indent="0" algn="ctr">
              <a:buNone/>
              <a:defRPr sz="2100"/>
            </a:lvl5pPr>
            <a:lvl6pPr marL="2999918" indent="0" algn="ctr">
              <a:buNone/>
              <a:defRPr sz="2100"/>
            </a:lvl6pPr>
            <a:lvl7pPr marL="3599901" indent="0" algn="ctr">
              <a:buNone/>
              <a:defRPr sz="2100"/>
            </a:lvl7pPr>
            <a:lvl8pPr marL="4199885" indent="0" algn="ctr">
              <a:buNone/>
              <a:defRPr sz="2100"/>
            </a:lvl8pPr>
            <a:lvl9pPr marL="4799868" indent="0" algn="ctr">
              <a:buNone/>
              <a:defRPr sz="2100"/>
            </a:lvl9pPr>
          </a:lstStyle>
          <a:p>
            <a:r>
              <a:rPr lang="hu-HU" smtClean="0"/>
              <a:t>Alcím mintájának szerkesztés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28937-BC61-4B29-9217-D5EB8F8DDD12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32C70-3296-4BEE-8221-C771417D74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93615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28937-BC61-4B29-9217-D5EB8F8DDD12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32C70-3296-4BEE-8221-C771417D74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94298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79142"/>
            <a:ext cx="2628900" cy="7626692"/>
          </a:xfrm>
        </p:spPr>
        <p:txBody>
          <a:bodyPr vert="eaVert"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79142"/>
            <a:ext cx="7734300" cy="7626692"/>
          </a:xfrm>
        </p:spPr>
        <p:txBody>
          <a:bodyPr vert="eaVert"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28937-BC61-4B29-9217-D5EB8F8DDD12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32C70-3296-4BEE-8221-C771417D74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35343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28937-BC61-4B29-9217-D5EB8F8DDD12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32C70-3296-4BEE-8221-C771417D74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96587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243638"/>
            <a:ext cx="10515600" cy="3743557"/>
          </a:xfrm>
        </p:spPr>
        <p:txBody>
          <a:bodyPr anchor="b"/>
          <a:lstStyle>
            <a:lvl1pPr>
              <a:defRPr sz="7874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6022610"/>
            <a:ext cx="10515600" cy="1968648"/>
          </a:xfrm>
        </p:spPr>
        <p:txBody>
          <a:bodyPr/>
          <a:lstStyle>
            <a:lvl1pPr marL="0" indent="0">
              <a:buNone/>
              <a:defRPr sz="3150">
                <a:solidFill>
                  <a:schemeClr val="tx1"/>
                </a:solidFill>
              </a:defRPr>
            </a:lvl1pPr>
            <a:lvl2pPr marL="599984" indent="0">
              <a:buNone/>
              <a:defRPr sz="2625">
                <a:solidFill>
                  <a:schemeClr val="tx1">
                    <a:tint val="75000"/>
                  </a:schemeClr>
                </a:solidFill>
              </a:defRPr>
            </a:lvl2pPr>
            <a:lvl3pPr marL="1199967" indent="0">
              <a:buNone/>
              <a:defRPr sz="2362">
                <a:solidFill>
                  <a:schemeClr val="tx1">
                    <a:tint val="75000"/>
                  </a:schemeClr>
                </a:solidFill>
              </a:defRPr>
            </a:lvl3pPr>
            <a:lvl4pPr marL="179995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4pPr>
            <a:lvl5pPr marL="2399934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5pPr>
            <a:lvl6pPr marL="299991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6pPr>
            <a:lvl7pPr marL="3599901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7pPr>
            <a:lvl8pPr marL="4199885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8pPr>
            <a:lvl9pPr marL="4799868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28937-BC61-4B29-9217-D5EB8F8DDD12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32C70-3296-4BEE-8221-C771417D74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32729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395710"/>
            <a:ext cx="5181600" cy="5710124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395710"/>
            <a:ext cx="5181600" cy="5710124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28937-BC61-4B29-9217-D5EB8F8DDD12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32C70-3296-4BEE-8221-C771417D74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97335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79144"/>
            <a:ext cx="10515600" cy="1739495"/>
          </a:xfrm>
        </p:spPr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206137"/>
            <a:ext cx="5157787" cy="1081194"/>
          </a:xfrm>
        </p:spPr>
        <p:txBody>
          <a:bodyPr anchor="b"/>
          <a:lstStyle>
            <a:lvl1pPr marL="0" indent="0">
              <a:buNone/>
              <a:defRPr sz="3150" b="1"/>
            </a:lvl1pPr>
            <a:lvl2pPr marL="599984" indent="0">
              <a:buNone/>
              <a:defRPr sz="2625" b="1"/>
            </a:lvl2pPr>
            <a:lvl3pPr marL="1199967" indent="0">
              <a:buNone/>
              <a:defRPr sz="2362" b="1"/>
            </a:lvl3pPr>
            <a:lvl4pPr marL="1799951" indent="0">
              <a:buNone/>
              <a:defRPr sz="2100" b="1"/>
            </a:lvl4pPr>
            <a:lvl5pPr marL="2399934" indent="0">
              <a:buNone/>
              <a:defRPr sz="2100" b="1"/>
            </a:lvl5pPr>
            <a:lvl6pPr marL="2999918" indent="0">
              <a:buNone/>
              <a:defRPr sz="2100" b="1"/>
            </a:lvl6pPr>
            <a:lvl7pPr marL="3599901" indent="0">
              <a:buNone/>
              <a:defRPr sz="2100" b="1"/>
            </a:lvl7pPr>
            <a:lvl8pPr marL="4199885" indent="0">
              <a:buNone/>
              <a:defRPr sz="2100" b="1"/>
            </a:lvl8pPr>
            <a:lvl9pPr marL="4799868" indent="0">
              <a:buNone/>
              <a:defRPr sz="21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287331"/>
            <a:ext cx="5157787" cy="4835169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206137"/>
            <a:ext cx="5183188" cy="1081194"/>
          </a:xfrm>
        </p:spPr>
        <p:txBody>
          <a:bodyPr anchor="b"/>
          <a:lstStyle>
            <a:lvl1pPr marL="0" indent="0">
              <a:buNone/>
              <a:defRPr sz="3150" b="1"/>
            </a:lvl1pPr>
            <a:lvl2pPr marL="599984" indent="0">
              <a:buNone/>
              <a:defRPr sz="2625" b="1"/>
            </a:lvl2pPr>
            <a:lvl3pPr marL="1199967" indent="0">
              <a:buNone/>
              <a:defRPr sz="2362" b="1"/>
            </a:lvl3pPr>
            <a:lvl4pPr marL="1799951" indent="0">
              <a:buNone/>
              <a:defRPr sz="2100" b="1"/>
            </a:lvl4pPr>
            <a:lvl5pPr marL="2399934" indent="0">
              <a:buNone/>
              <a:defRPr sz="2100" b="1"/>
            </a:lvl5pPr>
            <a:lvl6pPr marL="2999918" indent="0">
              <a:buNone/>
              <a:defRPr sz="2100" b="1"/>
            </a:lvl6pPr>
            <a:lvl7pPr marL="3599901" indent="0">
              <a:buNone/>
              <a:defRPr sz="2100" b="1"/>
            </a:lvl7pPr>
            <a:lvl8pPr marL="4199885" indent="0">
              <a:buNone/>
              <a:defRPr sz="2100" b="1"/>
            </a:lvl8pPr>
            <a:lvl9pPr marL="4799868" indent="0">
              <a:buNone/>
              <a:defRPr sz="2100" b="1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287331"/>
            <a:ext cx="5183188" cy="4835169"/>
          </a:xfrm>
        </p:spPr>
        <p:txBody>
          <a:bodyPr/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28937-BC61-4B29-9217-D5EB8F8DDD12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32C70-3296-4BEE-8221-C771417D74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97081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28937-BC61-4B29-9217-D5EB8F8DDD12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32C70-3296-4BEE-8221-C771417D74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04967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28937-BC61-4B29-9217-D5EB8F8DDD12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32C70-3296-4BEE-8221-C771417D74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31113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99969"/>
            <a:ext cx="3932237" cy="2099892"/>
          </a:xfrm>
        </p:spPr>
        <p:txBody>
          <a:bodyPr anchor="b"/>
          <a:lstStyle>
            <a:lvl1pPr>
              <a:defRPr sz="4199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295769"/>
            <a:ext cx="6172200" cy="6395505"/>
          </a:xfrm>
        </p:spPr>
        <p:txBody>
          <a:bodyPr/>
          <a:lstStyle>
            <a:lvl1pPr>
              <a:defRPr sz="4199"/>
            </a:lvl1pPr>
            <a:lvl2pPr>
              <a:defRPr sz="3674"/>
            </a:lvl2pPr>
            <a:lvl3pPr>
              <a:defRPr sz="3150"/>
            </a:lvl3pPr>
            <a:lvl4pPr>
              <a:defRPr sz="2625"/>
            </a:lvl4pPr>
            <a:lvl5pPr>
              <a:defRPr sz="2625"/>
            </a:lvl5pPr>
            <a:lvl6pPr>
              <a:defRPr sz="2625"/>
            </a:lvl6pPr>
            <a:lvl7pPr>
              <a:defRPr sz="2625"/>
            </a:lvl7pPr>
            <a:lvl8pPr>
              <a:defRPr sz="2625"/>
            </a:lvl8pPr>
            <a:lvl9pPr>
              <a:defRPr sz="2625"/>
            </a:lvl9pPr>
          </a:lstStyle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699862"/>
            <a:ext cx="3932237" cy="5001827"/>
          </a:xfrm>
        </p:spPr>
        <p:txBody>
          <a:bodyPr/>
          <a:lstStyle>
            <a:lvl1pPr marL="0" indent="0">
              <a:buNone/>
              <a:defRPr sz="2100"/>
            </a:lvl1pPr>
            <a:lvl2pPr marL="599984" indent="0">
              <a:buNone/>
              <a:defRPr sz="1837"/>
            </a:lvl2pPr>
            <a:lvl3pPr marL="1199967" indent="0">
              <a:buNone/>
              <a:defRPr sz="1575"/>
            </a:lvl3pPr>
            <a:lvl4pPr marL="1799951" indent="0">
              <a:buNone/>
              <a:defRPr sz="1312"/>
            </a:lvl4pPr>
            <a:lvl5pPr marL="2399934" indent="0">
              <a:buNone/>
              <a:defRPr sz="1312"/>
            </a:lvl5pPr>
            <a:lvl6pPr marL="2999918" indent="0">
              <a:buNone/>
              <a:defRPr sz="1312"/>
            </a:lvl6pPr>
            <a:lvl7pPr marL="3599901" indent="0">
              <a:buNone/>
              <a:defRPr sz="1312"/>
            </a:lvl7pPr>
            <a:lvl8pPr marL="4199885" indent="0">
              <a:buNone/>
              <a:defRPr sz="1312"/>
            </a:lvl8pPr>
            <a:lvl9pPr marL="4799868" indent="0">
              <a:buNone/>
              <a:defRPr sz="1312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28937-BC61-4B29-9217-D5EB8F8DDD12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32C70-3296-4BEE-8221-C771417D74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91740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599969"/>
            <a:ext cx="3932237" cy="2099892"/>
          </a:xfrm>
        </p:spPr>
        <p:txBody>
          <a:bodyPr anchor="b"/>
          <a:lstStyle>
            <a:lvl1pPr>
              <a:defRPr sz="4199"/>
            </a:lvl1pPr>
          </a:lstStyle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295769"/>
            <a:ext cx="6172200" cy="6395505"/>
          </a:xfrm>
        </p:spPr>
        <p:txBody>
          <a:bodyPr anchor="t"/>
          <a:lstStyle>
            <a:lvl1pPr marL="0" indent="0">
              <a:buNone/>
              <a:defRPr sz="4199"/>
            </a:lvl1pPr>
            <a:lvl2pPr marL="599984" indent="0">
              <a:buNone/>
              <a:defRPr sz="3674"/>
            </a:lvl2pPr>
            <a:lvl3pPr marL="1199967" indent="0">
              <a:buNone/>
              <a:defRPr sz="3150"/>
            </a:lvl3pPr>
            <a:lvl4pPr marL="1799951" indent="0">
              <a:buNone/>
              <a:defRPr sz="2625"/>
            </a:lvl4pPr>
            <a:lvl5pPr marL="2399934" indent="0">
              <a:buNone/>
              <a:defRPr sz="2625"/>
            </a:lvl5pPr>
            <a:lvl6pPr marL="2999918" indent="0">
              <a:buNone/>
              <a:defRPr sz="2625"/>
            </a:lvl6pPr>
            <a:lvl7pPr marL="3599901" indent="0">
              <a:buNone/>
              <a:defRPr sz="2625"/>
            </a:lvl7pPr>
            <a:lvl8pPr marL="4199885" indent="0">
              <a:buNone/>
              <a:defRPr sz="2625"/>
            </a:lvl8pPr>
            <a:lvl9pPr marL="4799868" indent="0">
              <a:buNone/>
              <a:defRPr sz="2625"/>
            </a:lvl9pPr>
          </a:lstStyle>
          <a:p>
            <a:r>
              <a:rPr lang="hu-HU" smtClean="0"/>
              <a:t>Kép beszúrásához kattintson az ikonra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699862"/>
            <a:ext cx="3932237" cy="5001827"/>
          </a:xfrm>
        </p:spPr>
        <p:txBody>
          <a:bodyPr/>
          <a:lstStyle>
            <a:lvl1pPr marL="0" indent="0">
              <a:buNone/>
              <a:defRPr sz="2100"/>
            </a:lvl1pPr>
            <a:lvl2pPr marL="599984" indent="0">
              <a:buNone/>
              <a:defRPr sz="1837"/>
            </a:lvl2pPr>
            <a:lvl3pPr marL="1199967" indent="0">
              <a:buNone/>
              <a:defRPr sz="1575"/>
            </a:lvl3pPr>
            <a:lvl4pPr marL="1799951" indent="0">
              <a:buNone/>
              <a:defRPr sz="1312"/>
            </a:lvl4pPr>
            <a:lvl5pPr marL="2399934" indent="0">
              <a:buNone/>
              <a:defRPr sz="1312"/>
            </a:lvl5pPr>
            <a:lvl6pPr marL="2999918" indent="0">
              <a:buNone/>
              <a:defRPr sz="1312"/>
            </a:lvl6pPr>
            <a:lvl7pPr marL="3599901" indent="0">
              <a:buNone/>
              <a:defRPr sz="1312"/>
            </a:lvl7pPr>
            <a:lvl8pPr marL="4199885" indent="0">
              <a:buNone/>
              <a:defRPr sz="1312"/>
            </a:lvl8pPr>
            <a:lvl9pPr marL="4799868" indent="0">
              <a:buNone/>
              <a:defRPr sz="1312"/>
            </a:lvl9pPr>
          </a:lstStyle>
          <a:p>
            <a:pPr lvl="0"/>
            <a:r>
              <a:rPr lang="hu-HU" smtClean="0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D328937-BC61-4B29-9217-D5EB8F8DDD12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8032C70-3296-4BEE-8221-C771417D74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27210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79144"/>
            <a:ext cx="10515600" cy="1739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 smtClean="0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395710"/>
            <a:ext cx="10515600" cy="571012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 smtClean="0"/>
              <a:t>Mintaszöveg szerkesztése</a:t>
            </a:r>
          </a:p>
          <a:p>
            <a:pPr lvl="1"/>
            <a:r>
              <a:rPr lang="hu-HU" smtClean="0"/>
              <a:t>Második szint</a:t>
            </a:r>
          </a:p>
          <a:p>
            <a:pPr lvl="2"/>
            <a:r>
              <a:rPr lang="hu-HU" smtClean="0"/>
              <a:t>Harmadik szint</a:t>
            </a:r>
          </a:p>
          <a:p>
            <a:pPr lvl="3"/>
            <a:r>
              <a:rPr lang="hu-HU" smtClean="0"/>
              <a:t>Negyedik szint</a:t>
            </a:r>
          </a:p>
          <a:p>
            <a:pPr lvl="4"/>
            <a:r>
              <a:rPr lang="hu-HU" smtClean="0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8341240"/>
            <a:ext cx="274320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328937-BC61-4B29-9217-D5EB8F8DDD12}" type="datetimeFigureOut">
              <a:rPr lang="en-US" smtClean="0"/>
              <a:t>3/30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8341240"/>
            <a:ext cx="411480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8341240"/>
            <a:ext cx="2743200" cy="47914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032C70-3296-4BEE-8221-C771417D74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90753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199967" rtl="0" eaLnBrk="1" latinLnBrk="0" hangingPunct="1">
        <a:lnSpc>
          <a:spcPct val="90000"/>
        </a:lnSpc>
        <a:spcBef>
          <a:spcPct val="0"/>
        </a:spcBef>
        <a:buNone/>
        <a:defRPr sz="577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99992" indent="-299992" algn="l" defTabSz="1199967" rtl="0" eaLnBrk="1" latinLnBrk="0" hangingPunct="1">
        <a:lnSpc>
          <a:spcPct val="90000"/>
        </a:lnSpc>
        <a:spcBef>
          <a:spcPts val="1312"/>
        </a:spcBef>
        <a:buFont typeface="Arial" panose="020B0604020202020204" pitchFamily="34" charset="0"/>
        <a:buChar char="•"/>
        <a:defRPr sz="3674" kern="1200">
          <a:solidFill>
            <a:schemeClr val="tx1"/>
          </a:solidFill>
          <a:latin typeface="+mn-lt"/>
          <a:ea typeface="+mn-ea"/>
          <a:cs typeface="+mn-cs"/>
        </a:defRPr>
      </a:lvl1pPr>
      <a:lvl2pPr marL="899975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3150" kern="1200">
          <a:solidFill>
            <a:schemeClr val="tx1"/>
          </a:solidFill>
          <a:latin typeface="+mn-lt"/>
          <a:ea typeface="+mn-ea"/>
          <a:cs typeface="+mn-cs"/>
        </a:defRPr>
      </a:lvl2pPr>
      <a:lvl3pPr marL="1499959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625" kern="1200">
          <a:solidFill>
            <a:schemeClr val="tx1"/>
          </a:solidFill>
          <a:latin typeface="+mn-lt"/>
          <a:ea typeface="+mn-ea"/>
          <a:cs typeface="+mn-cs"/>
        </a:defRPr>
      </a:lvl3pPr>
      <a:lvl4pPr marL="2099942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4pPr>
      <a:lvl5pPr marL="2699926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5pPr>
      <a:lvl6pPr marL="3299910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6pPr>
      <a:lvl7pPr marL="3899893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7pPr>
      <a:lvl8pPr marL="4499877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8pPr>
      <a:lvl9pPr marL="5099860" indent="-299992" algn="l" defTabSz="1199967" rtl="0" eaLnBrk="1" latinLnBrk="0" hangingPunct="1">
        <a:lnSpc>
          <a:spcPct val="90000"/>
        </a:lnSpc>
        <a:spcBef>
          <a:spcPts val="656"/>
        </a:spcBef>
        <a:buFont typeface="Arial" panose="020B0604020202020204" pitchFamily="34" charset="0"/>
        <a:buChar char="•"/>
        <a:defRPr sz="236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1pPr>
      <a:lvl2pPr marL="599984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2pPr>
      <a:lvl3pPr marL="1199967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3pPr>
      <a:lvl4pPr marL="1799951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4pPr>
      <a:lvl5pPr marL="2399934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5pPr>
      <a:lvl6pPr marL="2999918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6pPr>
      <a:lvl7pPr marL="3599901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7pPr>
      <a:lvl8pPr marL="4199885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8pPr>
      <a:lvl9pPr marL="4799868" algn="l" defTabSz="1199967" rtl="0" eaLnBrk="1" latinLnBrk="0" hangingPunct="1">
        <a:defRPr sz="236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jpeg"/><Relationship Id="rId3" Type="http://schemas.openxmlformats.org/officeDocument/2006/relationships/image" Target="../media/image2.png"/><Relationship Id="rId7" Type="http://schemas.openxmlformats.org/officeDocument/2006/relationships/image" Target="../media/image5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microsoft.com/office/2007/relationships/hdphoto" Target="../media/hdphoto1.wdp"/><Relationship Id="rId9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Kép 1"/>
          <p:cNvPicPr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208" t="7764" r="12956" b="11130"/>
          <a:stretch/>
        </p:blipFill>
        <p:spPr>
          <a:xfrm>
            <a:off x="4936323" y="374910"/>
            <a:ext cx="1800000" cy="1800000"/>
          </a:xfrm>
          <a:prstGeom prst="rect">
            <a:avLst/>
          </a:prstGeom>
        </p:spPr>
      </p:pic>
      <p:pic>
        <p:nvPicPr>
          <p:cNvPr id="3" name="Kép 2"/>
          <p:cNvPicPr>
            <a:picLocks/>
          </p:cNvPicPr>
          <p:nvPr/>
        </p:nvPicPr>
        <p:blipFill rotWithShape="1">
          <a:blip r:embed="rId3" cstate="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7000" contrast="1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3428" t="16807" r="11667" b="1680"/>
          <a:stretch/>
        </p:blipFill>
        <p:spPr>
          <a:xfrm>
            <a:off x="3064323" y="374910"/>
            <a:ext cx="1800000" cy="1800000"/>
          </a:xfrm>
          <a:prstGeom prst="rect">
            <a:avLst/>
          </a:prstGeom>
        </p:spPr>
      </p:pic>
      <p:sp>
        <p:nvSpPr>
          <p:cNvPr id="4" name="Szövegdoboz 3"/>
          <p:cNvSpPr txBox="1"/>
          <p:nvPr/>
        </p:nvSpPr>
        <p:spPr>
          <a:xfrm>
            <a:off x="3601546" y="6093163"/>
            <a:ext cx="7745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293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Kép 4"/>
          <p:cNvPicPr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86" t="5470" r="18768" b="4311"/>
          <a:stretch/>
        </p:blipFill>
        <p:spPr>
          <a:xfrm rot="16200000">
            <a:off x="4936323" y="2257668"/>
            <a:ext cx="1799997" cy="1800000"/>
          </a:xfrm>
          <a:prstGeom prst="rect">
            <a:avLst/>
          </a:prstGeom>
        </p:spPr>
      </p:pic>
      <p:pic>
        <p:nvPicPr>
          <p:cNvPr id="6" name="Kép 5"/>
          <p:cNvPicPr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022" t="7570" r="22542" b="1776"/>
          <a:stretch/>
        </p:blipFill>
        <p:spPr>
          <a:xfrm rot="16200000">
            <a:off x="3064323" y="4129668"/>
            <a:ext cx="1799999" cy="1800000"/>
          </a:xfrm>
          <a:prstGeom prst="rect">
            <a:avLst/>
          </a:prstGeom>
        </p:spPr>
      </p:pic>
      <p:pic>
        <p:nvPicPr>
          <p:cNvPr id="7" name="Kép 6"/>
          <p:cNvPicPr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764" t="6067" r="22546" b="3962"/>
          <a:stretch/>
        </p:blipFill>
        <p:spPr>
          <a:xfrm rot="16200000" flipV="1">
            <a:off x="3064323" y="2257668"/>
            <a:ext cx="1800000" cy="1800000"/>
          </a:xfrm>
          <a:prstGeom prst="rect">
            <a:avLst/>
          </a:prstGeom>
        </p:spPr>
      </p:pic>
      <p:sp>
        <p:nvSpPr>
          <p:cNvPr id="8" name="Szövegdoboz 7"/>
          <p:cNvSpPr txBox="1"/>
          <p:nvPr/>
        </p:nvSpPr>
        <p:spPr>
          <a:xfrm>
            <a:off x="5192221" y="6093163"/>
            <a:ext cx="116730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i="1" dirty="0" smtClean="0">
                <a:latin typeface="Symbol" panose="05050102010706020507" pitchFamily="18" charset="2"/>
                <a:cs typeface="Times New Roman" panose="02020603050405020304" pitchFamily="18" charset="0"/>
              </a:rPr>
              <a:t>D</a:t>
            </a:r>
            <a:r>
              <a:rPr lang="en-US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uB</a:t>
            </a:r>
            <a:r>
              <a:rPr lang="en-US" i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U80</a:t>
            </a:r>
            <a:endParaRPr lang="en-US" i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Szövegdoboz 8"/>
          <p:cNvSpPr txBox="1"/>
          <p:nvPr/>
        </p:nvSpPr>
        <p:spPr>
          <a:xfrm>
            <a:off x="520338" y="188275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0" name="Kép 9"/>
          <p:cNvPicPr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143" t="9162" r="16632" b="7597"/>
          <a:stretch/>
        </p:blipFill>
        <p:spPr>
          <a:xfrm>
            <a:off x="4936322" y="4131531"/>
            <a:ext cx="1800000" cy="1800000"/>
          </a:xfrm>
          <a:prstGeom prst="rect">
            <a:avLst/>
          </a:prstGeom>
        </p:spPr>
      </p:pic>
      <p:graphicFrame>
        <p:nvGraphicFramePr>
          <p:cNvPr id="12" name="Diagram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56150784"/>
              </p:ext>
            </p:extLst>
          </p:nvPr>
        </p:nvGraphicFramePr>
        <p:xfrm>
          <a:off x="6957605" y="179405"/>
          <a:ext cx="4572000" cy="644730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sp>
        <p:nvSpPr>
          <p:cNvPr id="13" name="Téglalap 12"/>
          <p:cNvSpPr/>
          <p:nvPr/>
        </p:nvSpPr>
        <p:spPr>
          <a:xfrm>
            <a:off x="515118" y="179405"/>
            <a:ext cx="11014487" cy="654412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Szövegdoboz 15"/>
          <p:cNvSpPr txBox="1"/>
          <p:nvPr/>
        </p:nvSpPr>
        <p:spPr>
          <a:xfrm>
            <a:off x="10357511" y="566869"/>
            <a:ext cx="949299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293</a:t>
            </a:r>
          </a:p>
          <a:p>
            <a:r>
              <a:rPr lang="en-US" sz="1400" i="1" dirty="0" smtClean="0">
                <a:latin typeface="Symbol" panose="05050102010706020507" pitchFamily="18" charset="2"/>
                <a:cs typeface="Times New Roman" panose="02020603050405020304" pitchFamily="18" charset="0"/>
              </a:rPr>
              <a:t>D</a:t>
            </a:r>
            <a:r>
              <a:rPr lang="en-US" sz="14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uB</a:t>
            </a:r>
            <a:r>
              <a:rPr lang="en-US" sz="1400" i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U80</a:t>
            </a:r>
            <a:endParaRPr lang="en-US" sz="1400" i="1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églalap 16"/>
          <p:cNvSpPr/>
          <p:nvPr/>
        </p:nvSpPr>
        <p:spPr>
          <a:xfrm>
            <a:off x="6957605" y="1081272"/>
            <a:ext cx="185472" cy="4297548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Szövegdoboz 17"/>
          <p:cNvSpPr txBox="1"/>
          <p:nvPr/>
        </p:nvSpPr>
        <p:spPr>
          <a:xfrm>
            <a:off x="515118" y="952176"/>
            <a:ext cx="255069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0 </a:t>
            </a:r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NaNO</a:t>
            </a:r>
            <a:r>
              <a:rPr lang="en-US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pH 4.5)</a:t>
            </a:r>
            <a:endParaRPr lang="hu-HU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hu-HU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hu-HU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hibition</a:t>
            </a:r>
            <a:r>
              <a:rPr lang="hu-HU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zone</a:t>
            </a:r>
            <a:r>
              <a:rPr lang="hu-HU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Szövegdoboz 18"/>
          <p:cNvSpPr txBox="1"/>
          <p:nvPr/>
        </p:nvSpPr>
        <p:spPr>
          <a:xfrm>
            <a:off x="622695" y="4702537"/>
            <a:ext cx="243528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 </a:t>
            </a:r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NaNO</a:t>
            </a:r>
            <a:r>
              <a:rPr lang="en-US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pH 4.5)</a:t>
            </a:r>
            <a:endParaRPr lang="hu-HU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olony</a:t>
            </a:r>
            <a:r>
              <a:rPr lang="hu-HU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ameter</a:t>
            </a:r>
            <a:r>
              <a:rPr lang="hu-HU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Szövegdoboz 19"/>
          <p:cNvSpPr txBox="1"/>
          <p:nvPr/>
        </p:nvSpPr>
        <p:spPr>
          <a:xfrm>
            <a:off x="1041755" y="2819782"/>
            <a:ext cx="201208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hu-HU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ntreated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pH 4.5)</a:t>
            </a:r>
            <a:endParaRPr lang="hu-HU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r"/>
            <a:r>
              <a:rPr lang="hu-HU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hu-HU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lony</a:t>
            </a:r>
            <a:r>
              <a:rPr lang="hu-HU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hu-HU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ameter</a:t>
            </a:r>
            <a:r>
              <a:rPr lang="hu-HU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Szövegdoboz 20"/>
          <p:cNvSpPr txBox="1"/>
          <p:nvPr/>
        </p:nvSpPr>
        <p:spPr>
          <a:xfrm>
            <a:off x="6881907" y="197955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2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en-US" sz="2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Szövegdoboz 21"/>
          <p:cNvSpPr txBox="1"/>
          <p:nvPr/>
        </p:nvSpPr>
        <p:spPr>
          <a:xfrm>
            <a:off x="10271887" y="2751957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Szövegdoboz 22"/>
          <p:cNvSpPr txBox="1"/>
          <p:nvPr/>
        </p:nvSpPr>
        <p:spPr>
          <a:xfrm>
            <a:off x="8223325" y="916625"/>
            <a:ext cx="25519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Szövegdoboz 23"/>
          <p:cNvSpPr txBox="1"/>
          <p:nvPr/>
        </p:nvSpPr>
        <p:spPr>
          <a:xfrm>
            <a:off x="9228755" y="4602438"/>
            <a:ext cx="34977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,t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Szövegdoboz 24"/>
          <p:cNvSpPr txBox="1"/>
          <p:nvPr/>
        </p:nvSpPr>
        <p:spPr>
          <a:xfrm>
            <a:off x="434274" y="6732396"/>
            <a:ext cx="11095331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3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NaNO</a:t>
            </a:r>
            <a:r>
              <a:rPr lang="en-US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ensitivity of the </a:t>
            </a:r>
            <a:r>
              <a:rPr lang="en-US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spergillus fumigatus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293 and </a:t>
            </a:r>
            <a:r>
              <a:rPr lang="en-US" i="1" dirty="0" smtClean="0">
                <a:latin typeface="Symbol" panose="05050102010706020507" pitchFamily="18" charset="2"/>
                <a:cs typeface="Times New Roman" panose="02020603050405020304" pitchFamily="18" charset="0"/>
              </a:rPr>
              <a:t>D</a:t>
            </a:r>
            <a:r>
              <a:rPr lang="en-US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kuB</a:t>
            </a:r>
            <a:r>
              <a:rPr lang="en-US" i="1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U80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trains.</a:t>
            </a:r>
          </a:p>
          <a:p>
            <a:pPr algn="just"/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nel A: Representative photos taken after 5 days incubation are presented. Diameter of the Petri-dish is 85 mm. In the case of the agar diffusion assays, 50 </a:t>
            </a:r>
            <a:r>
              <a:rPr lang="en-US" dirty="0" smtClean="0">
                <a:latin typeface="Symbol" panose="05050102010706020507" pitchFamily="18" charset="2"/>
                <a:cs typeface="Times New Roman" panose="02020603050405020304" pitchFamily="18" charset="0"/>
              </a:rPr>
              <a:t>m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 500 </a:t>
            </a:r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M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NaNO</a:t>
            </a:r>
            <a:r>
              <a:rPr lang="en-US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as added to the wells (with 5 mm diameter) immediately after inoculation.</a:t>
            </a:r>
          </a:p>
          <a:p>
            <a:pPr algn="just"/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anel B: Mean ± SD (n = 3) are presented. </a:t>
            </a:r>
            <a:r>
              <a:rPr lang="en-US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– Significant difference (Student’s t-test, </a:t>
            </a:r>
            <a:r>
              <a:rPr lang="en-US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&lt; 0.05) between the two strains growing in the same conditions. </a:t>
            </a:r>
            <a:r>
              <a:rPr lang="en-US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– Significant difference (Student’s t-test, </a:t>
            </a:r>
            <a:r>
              <a:rPr lang="en-US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&lt; 0.05) between the NaNO</a:t>
            </a:r>
            <a:r>
              <a:rPr lang="en-US" baseline="-25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reated and relevant untreated cultures. 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Szövegdoboz 25"/>
          <p:cNvSpPr txBox="1"/>
          <p:nvPr/>
        </p:nvSpPr>
        <p:spPr>
          <a:xfrm>
            <a:off x="9596966" y="5071043"/>
            <a:ext cx="23436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0667303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éma">
  <a:themeElements>
    <a:clrScheme name="Office-té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éma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é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9</TotalTime>
  <Words>168</Words>
  <Application>Microsoft Office PowerPoint</Application>
  <PresentationFormat>Egyéni</PresentationFormat>
  <Paragraphs>20</Paragraphs>
  <Slides>1</Slides>
  <Notes>0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5</vt:i4>
      </vt:variant>
      <vt:variant>
        <vt:lpstr>Téma</vt:lpstr>
      </vt:variant>
      <vt:variant>
        <vt:i4>1</vt:i4>
      </vt:variant>
      <vt:variant>
        <vt:lpstr>Diacímek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Office-téma</vt:lpstr>
      <vt:lpstr>PowerPoint-bemutat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bemutató</dc:title>
  <dc:creator>Dr Emri Tamás</dc:creator>
  <cp:lastModifiedBy>Tanar</cp:lastModifiedBy>
  <cp:revision>14</cp:revision>
  <dcterms:created xsi:type="dcterms:W3CDTF">2024-12-17T14:50:54Z</dcterms:created>
  <dcterms:modified xsi:type="dcterms:W3CDTF">2025-03-30T18:47:55Z</dcterms:modified>
</cp:coreProperties>
</file>